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6" autoAdjust="0"/>
    <p:restoredTop sz="94660"/>
  </p:normalViewPr>
  <p:slideViewPr>
    <p:cSldViewPr snapToGrid="0">
      <p:cViewPr varScale="1">
        <p:scale>
          <a:sx n="65" d="100"/>
          <a:sy n="65" d="100"/>
        </p:scale>
        <p:origin x="1347" y="3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6267F-625F-4555-A7C8-6ABB35ACB53A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B321-B576-43CF-A36E-37BA53A6158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65219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6267F-625F-4555-A7C8-6ABB35ACB53A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B321-B576-43CF-A36E-37BA53A6158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71424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6267F-625F-4555-A7C8-6ABB35ACB53A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B321-B576-43CF-A36E-37BA53A6158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797652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6267F-625F-4555-A7C8-6ABB35ACB53A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B321-B576-43CF-A36E-37BA53A6158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820038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6267F-625F-4555-A7C8-6ABB35ACB53A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B321-B576-43CF-A36E-37BA53A6158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795879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6267F-625F-4555-A7C8-6ABB35ACB53A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B321-B576-43CF-A36E-37BA53A6158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98335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6267F-625F-4555-A7C8-6ABB35ACB53A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B321-B576-43CF-A36E-37BA53A6158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08383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6267F-625F-4555-A7C8-6ABB35ACB53A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B321-B576-43CF-A36E-37BA53A6158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956729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6267F-625F-4555-A7C8-6ABB35ACB53A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B321-B576-43CF-A36E-37BA53A6158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89187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6267F-625F-4555-A7C8-6ABB35ACB53A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B321-B576-43CF-A36E-37BA53A6158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20817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6267F-625F-4555-A7C8-6ABB35ACB53A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B321-B576-43CF-A36E-37BA53A6158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46947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66267F-625F-4555-A7C8-6ABB35ACB53A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C2B321-B576-43CF-A36E-37BA53A6158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93204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字方塊 4"/>
          <p:cNvSpPr txBox="1"/>
          <p:nvPr/>
        </p:nvSpPr>
        <p:spPr>
          <a:xfrm>
            <a:off x="955281" y="4663444"/>
            <a:ext cx="74553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>
                <a:latin typeface="Bell MT" panose="02020503060305020303" pitchFamily="18" charset="0"/>
              </a:rPr>
              <a:t>Supplemental Figure S2. Relative risks of ERVs for asthma </a:t>
            </a:r>
            <a:r>
              <a:rPr lang="en-US" altLang="zh-TW" dirty="0">
                <a:latin typeface="Times New Roman"/>
                <a:cs typeface="Times New Roman"/>
              </a:rPr>
              <a:t>with an increase of (a) 10 ppb of NO</a:t>
            </a:r>
            <a:r>
              <a:rPr lang="en-US" altLang="zh-TW" baseline="-25000" dirty="0">
                <a:latin typeface="Times New Roman"/>
                <a:cs typeface="Times New Roman"/>
              </a:rPr>
              <a:t>2</a:t>
            </a:r>
            <a:r>
              <a:rPr lang="en-US" altLang="zh-TW" dirty="0">
                <a:latin typeface="Times New Roman"/>
                <a:cs typeface="Times New Roman"/>
              </a:rPr>
              <a:t> </a:t>
            </a:r>
            <a:r>
              <a:rPr lang="en-US" altLang="zh-TW" baseline="-25000" dirty="0">
                <a:latin typeface="Times New Roman"/>
                <a:cs typeface="Times New Roman"/>
              </a:rPr>
              <a:t> </a:t>
            </a:r>
            <a:r>
              <a:rPr lang="en-US" altLang="zh-TW" dirty="0">
                <a:latin typeface="Times New Roman"/>
                <a:cs typeface="Times New Roman"/>
              </a:rPr>
              <a:t>and (b) of 1 ppb of SO</a:t>
            </a:r>
            <a:r>
              <a:rPr lang="en-US" altLang="zh-TW" baseline="-25000" dirty="0">
                <a:latin typeface="Times New Roman"/>
                <a:cs typeface="Times New Roman"/>
              </a:rPr>
              <a:t>2</a:t>
            </a:r>
            <a:r>
              <a:rPr lang="en-US" altLang="zh-TW" dirty="0">
                <a:latin typeface="Times New Roman"/>
                <a:cs typeface="Times New Roman"/>
              </a:rPr>
              <a:t> during the Spring season.</a:t>
            </a:r>
            <a:r>
              <a:rPr lang="en-US" altLang="zh-TW" baseline="-25000" dirty="0">
                <a:latin typeface="Times New Roman"/>
                <a:cs typeface="Times New Roman"/>
              </a:rPr>
              <a:t> </a:t>
            </a:r>
            <a:endParaRPr lang="zh-TW" altLang="en-US" dirty="0">
              <a:latin typeface="Bell MT" panose="02020503060305020303" pitchFamily="18" charset="0"/>
            </a:endParaRPr>
          </a:p>
        </p:txBody>
      </p:sp>
      <p:pic>
        <p:nvPicPr>
          <p:cNvPr id="11" name="圖片 10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2401" y="1071595"/>
            <a:ext cx="6721749" cy="36409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26927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35</Words>
  <Application>Microsoft Office PowerPoint</Application>
  <PresentationFormat>如螢幕大小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8" baseType="lpstr">
      <vt:lpstr>新細明體</vt:lpstr>
      <vt:lpstr>Arial</vt:lpstr>
      <vt:lpstr>Bell MT</vt:lpstr>
      <vt:lpstr>Calibri</vt:lpstr>
      <vt:lpstr>Calibri Light</vt:lpstr>
      <vt:lpstr>Times New Roman</vt:lpstr>
      <vt:lpstr>Office 佈景主題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徐士昌</dc:creator>
  <cp:lastModifiedBy>徐士昌</cp:lastModifiedBy>
  <cp:revision>1</cp:revision>
  <dcterms:created xsi:type="dcterms:W3CDTF">2017-06-29T13:58:00Z</dcterms:created>
  <dcterms:modified xsi:type="dcterms:W3CDTF">2017-06-29T13:59:07Z</dcterms:modified>
</cp:coreProperties>
</file>